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10998200" cy="7564438"/>
  <p:notesSz cx="6865938" cy="9998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9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4865" y="1237977"/>
            <a:ext cx="9348470" cy="2633545"/>
          </a:xfrm>
        </p:spPr>
        <p:txBody>
          <a:bodyPr anchor="b"/>
          <a:lstStyle>
            <a:lvl1pPr algn="ctr">
              <a:defRPr sz="661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4775" y="3973081"/>
            <a:ext cx="8248650" cy="1826321"/>
          </a:xfrm>
        </p:spPr>
        <p:txBody>
          <a:bodyPr/>
          <a:lstStyle>
            <a:lvl1pPr marL="0" indent="0" algn="ctr">
              <a:buNone/>
              <a:defRPr sz="2647"/>
            </a:lvl1pPr>
            <a:lvl2pPr marL="504292" indent="0" algn="ctr">
              <a:buNone/>
              <a:defRPr sz="2206"/>
            </a:lvl2pPr>
            <a:lvl3pPr marL="1008583" indent="0" algn="ctr">
              <a:buNone/>
              <a:defRPr sz="1985"/>
            </a:lvl3pPr>
            <a:lvl4pPr marL="1512875" indent="0" algn="ctr">
              <a:buNone/>
              <a:defRPr sz="1765"/>
            </a:lvl4pPr>
            <a:lvl5pPr marL="2017166" indent="0" algn="ctr">
              <a:buNone/>
              <a:defRPr sz="1765"/>
            </a:lvl5pPr>
            <a:lvl6pPr marL="2521458" indent="0" algn="ctr">
              <a:buNone/>
              <a:defRPr sz="1765"/>
            </a:lvl6pPr>
            <a:lvl7pPr marL="3025750" indent="0" algn="ctr">
              <a:buNone/>
              <a:defRPr sz="1765"/>
            </a:lvl7pPr>
            <a:lvl8pPr marL="3530041" indent="0" algn="ctr">
              <a:buNone/>
              <a:defRPr sz="1765"/>
            </a:lvl8pPr>
            <a:lvl9pPr marL="4034333" indent="0" algn="ctr">
              <a:buNone/>
              <a:defRPr sz="176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8208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481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70587" y="402736"/>
            <a:ext cx="2371487" cy="641051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6127" y="402736"/>
            <a:ext cx="6976983" cy="641051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9751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3744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0398" y="1885858"/>
            <a:ext cx="9485948" cy="3146596"/>
          </a:xfrm>
        </p:spPr>
        <p:txBody>
          <a:bodyPr anchor="b"/>
          <a:lstStyle>
            <a:lvl1pPr>
              <a:defRPr sz="661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0398" y="5062222"/>
            <a:ext cx="9485948" cy="1654720"/>
          </a:xfrm>
        </p:spPr>
        <p:txBody>
          <a:bodyPr/>
          <a:lstStyle>
            <a:lvl1pPr marL="0" indent="0">
              <a:buNone/>
              <a:defRPr sz="2647">
                <a:solidFill>
                  <a:schemeClr val="tx1"/>
                </a:solidFill>
              </a:defRPr>
            </a:lvl1pPr>
            <a:lvl2pPr marL="504292" indent="0">
              <a:buNone/>
              <a:defRPr sz="2206">
                <a:solidFill>
                  <a:schemeClr val="tx1">
                    <a:tint val="75000"/>
                  </a:schemeClr>
                </a:solidFill>
              </a:defRPr>
            </a:lvl2pPr>
            <a:lvl3pPr marL="1008583" indent="0">
              <a:buNone/>
              <a:defRPr sz="1985">
                <a:solidFill>
                  <a:schemeClr val="tx1">
                    <a:tint val="75000"/>
                  </a:schemeClr>
                </a:solidFill>
              </a:defRPr>
            </a:lvl3pPr>
            <a:lvl4pPr marL="1512875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4pPr>
            <a:lvl5pPr marL="2017166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5pPr>
            <a:lvl6pPr marL="2521458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6pPr>
            <a:lvl7pPr marL="3025750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7pPr>
            <a:lvl8pPr marL="3530041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8pPr>
            <a:lvl9pPr marL="4034333" indent="0">
              <a:buNone/>
              <a:defRPr sz="176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2157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6126" y="2013682"/>
            <a:ext cx="4674235" cy="47995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67839" y="2013682"/>
            <a:ext cx="4674235" cy="47995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58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559" y="402738"/>
            <a:ext cx="9485948" cy="14621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7560" y="1854338"/>
            <a:ext cx="4652753" cy="908783"/>
          </a:xfrm>
        </p:spPr>
        <p:txBody>
          <a:bodyPr anchor="b"/>
          <a:lstStyle>
            <a:lvl1pPr marL="0" indent="0">
              <a:buNone/>
              <a:defRPr sz="2647" b="1"/>
            </a:lvl1pPr>
            <a:lvl2pPr marL="504292" indent="0">
              <a:buNone/>
              <a:defRPr sz="2206" b="1"/>
            </a:lvl2pPr>
            <a:lvl3pPr marL="1008583" indent="0">
              <a:buNone/>
              <a:defRPr sz="1985" b="1"/>
            </a:lvl3pPr>
            <a:lvl4pPr marL="1512875" indent="0">
              <a:buNone/>
              <a:defRPr sz="1765" b="1"/>
            </a:lvl4pPr>
            <a:lvl5pPr marL="2017166" indent="0">
              <a:buNone/>
              <a:defRPr sz="1765" b="1"/>
            </a:lvl5pPr>
            <a:lvl6pPr marL="2521458" indent="0">
              <a:buNone/>
              <a:defRPr sz="1765" b="1"/>
            </a:lvl6pPr>
            <a:lvl7pPr marL="3025750" indent="0">
              <a:buNone/>
              <a:defRPr sz="1765" b="1"/>
            </a:lvl7pPr>
            <a:lvl8pPr marL="3530041" indent="0">
              <a:buNone/>
              <a:defRPr sz="1765" b="1"/>
            </a:lvl8pPr>
            <a:lvl9pPr marL="4034333" indent="0">
              <a:buNone/>
              <a:defRPr sz="17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7560" y="2763121"/>
            <a:ext cx="4652753" cy="40641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67839" y="1854338"/>
            <a:ext cx="4675668" cy="908783"/>
          </a:xfrm>
        </p:spPr>
        <p:txBody>
          <a:bodyPr anchor="b"/>
          <a:lstStyle>
            <a:lvl1pPr marL="0" indent="0">
              <a:buNone/>
              <a:defRPr sz="2647" b="1"/>
            </a:lvl1pPr>
            <a:lvl2pPr marL="504292" indent="0">
              <a:buNone/>
              <a:defRPr sz="2206" b="1"/>
            </a:lvl2pPr>
            <a:lvl3pPr marL="1008583" indent="0">
              <a:buNone/>
              <a:defRPr sz="1985" b="1"/>
            </a:lvl3pPr>
            <a:lvl4pPr marL="1512875" indent="0">
              <a:buNone/>
              <a:defRPr sz="1765" b="1"/>
            </a:lvl4pPr>
            <a:lvl5pPr marL="2017166" indent="0">
              <a:buNone/>
              <a:defRPr sz="1765" b="1"/>
            </a:lvl5pPr>
            <a:lvl6pPr marL="2521458" indent="0">
              <a:buNone/>
              <a:defRPr sz="1765" b="1"/>
            </a:lvl6pPr>
            <a:lvl7pPr marL="3025750" indent="0">
              <a:buNone/>
              <a:defRPr sz="1765" b="1"/>
            </a:lvl7pPr>
            <a:lvl8pPr marL="3530041" indent="0">
              <a:buNone/>
              <a:defRPr sz="1765" b="1"/>
            </a:lvl8pPr>
            <a:lvl9pPr marL="4034333" indent="0">
              <a:buNone/>
              <a:defRPr sz="176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67839" y="2763121"/>
            <a:ext cx="4675668" cy="406413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961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7316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330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559" y="504296"/>
            <a:ext cx="3547206" cy="1765036"/>
          </a:xfrm>
        </p:spPr>
        <p:txBody>
          <a:bodyPr anchor="b"/>
          <a:lstStyle>
            <a:lvl1pPr>
              <a:defRPr sz="353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75667" y="1089141"/>
            <a:ext cx="5567839" cy="5375654"/>
          </a:xfrm>
        </p:spPr>
        <p:txBody>
          <a:bodyPr/>
          <a:lstStyle>
            <a:lvl1pPr>
              <a:defRPr sz="3530"/>
            </a:lvl1pPr>
            <a:lvl2pPr>
              <a:defRPr sz="3088"/>
            </a:lvl2pPr>
            <a:lvl3pPr>
              <a:defRPr sz="2647"/>
            </a:lvl3pPr>
            <a:lvl4pPr>
              <a:defRPr sz="2206"/>
            </a:lvl4pPr>
            <a:lvl5pPr>
              <a:defRPr sz="2206"/>
            </a:lvl5pPr>
            <a:lvl6pPr>
              <a:defRPr sz="2206"/>
            </a:lvl6pPr>
            <a:lvl7pPr>
              <a:defRPr sz="2206"/>
            </a:lvl7pPr>
            <a:lvl8pPr>
              <a:defRPr sz="2206"/>
            </a:lvl8pPr>
            <a:lvl9pPr>
              <a:defRPr sz="220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7559" y="2269331"/>
            <a:ext cx="3547206" cy="4204217"/>
          </a:xfrm>
        </p:spPr>
        <p:txBody>
          <a:bodyPr/>
          <a:lstStyle>
            <a:lvl1pPr marL="0" indent="0">
              <a:buNone/>
              <a:defRPr sz="1765"/>
            </a:lvl1pPr>
            <a:lvl2pPr marL="504292" indent="0">
              <a:buNone/>
              <a:defRPr sz="1544"/>
            </a:lvl2pPr>
            <a:lvl3pPr marL="1008583" indent="0">
              <a:buNone/>
              <a:defRPr sz="1324"/>
            </a:lvl3pPr>
            <a:lvl4pPr marL="1512875" indent="0">
              <a:buNone/>
              <a:defRPr sz="1103"/>
            </a:lvl4pPr>
            <a:lvl5pPr marL="2017166" indent="0">
              <a:buNone/>
              <a:defRPr sz="1103"/>
            </a:lvl5pPr>
            <a:lvl6pPr marL="2521458" indent="0">
              <a:buNone/>
              <a:defRPr sz="1103"/>
            </a:lvl6pPr>
            <a:lvl7pPr marL="3025750" indent="0">
              <a:buNone/>
              <a:defRPr sz="1103"/>
            </a:lvl7pPr>
            <a:lvl8pPr marL="3530041" indent="0">
              <a:buNone/>
              <a:defRPr sz="1103"/>
            </a:lvl8pPr>
            <a:lvl9pPr marL="4034333" indent="0">
              <a:buNone/>
              <a:defRPr sz="11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483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7559" y="504296"/>
            <a:ext cx="3547206" cy="1765036"/>
          </a:xfrm>
        </p:spPr>
        <p:txBody>
          <a:bodyPr anchor="b"/>
          <a:lstStyle>
            <a:lvl1pPr>
              <a:defRPr sz="353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75667" y="1089141"/>
            <a:ext cx="5567839" cy="5375654"/>
          </a:xfrm>
        </p:spPr>
        <p:txBody>
          <a:bodyPr anchor="t"/>
          <a:lstStyle>
            <a:lvl1pPr marL="0" indent="0">
              <a:buNone/>
              <a:defRPr sz="3530"/>
            </a:lvl1pPr>
            <a:lvl2pPr marL="504292" indent="0">
              <a:buNone/>
              <a:defRPr sz="3088"/>
            </a:lvl2pPr>
            <a:lvl3pPr marL="1008583" indent="0">
              <a:buNone/>
              <a:defRPr sz="2647"/>
            </a:lvl3pPr>
            <a:lvl4pPr marL="1512875" indent="0">
              <a:buNone/>
              <a:defRPr sz="2206"/>
            </a:lvl4pPr>
            <a:lvl5pPr marL="2017166" indent="0">
              <a:buNone/>
              <a:defRPr sz="2206"/>
            </a:lvl5pPr>
            <a:lvl6pPr marL="2521458" indent="0">
              <a:buNone/>
              <a:defRPr sz="2206"/>
            </a:lvl6pPr>
            <a:lvl7pPr marL="3025750" indent="0">
              <a:buNone/>
              <a:defRPr sz="2206"/>
            </a:lvl7pPr>
            <a:lvl8pPr marL="3530041" indent="0">
              <a:buNone/>
              <a:defRPr sz="2206"/>
            </a:lvl8pPr>
            <a:lvl9pPr marL="4034333" indent="0">
              <a:buNone/>
              <a:defRPr sz="220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7559" y="2269331"/>
            <a:ext cx="3547206" cy="4204217"/>
          </a:xfrm>
        </p:spPr>
        <p:txBody>
          <a:bodyPr/>
          <a:lstStyle>
            <a:lvl1pPr marL="0" indent="0">
              <a:buNone/>
              <a:defRPr sz="1765"/>
            </a:lvl1pPr>
            <a:lvl2pPr marL="504292" indent="0">
              <a:buNone/>
              <a:defRPr sz="1544"/>
            </a:lvl2pPr>
            <a:lvl3pPr marL="1008583" indent="0">
              <a:buNone/>
              <a:defRPr sz="1324"/>
            </a:lvl3pPr>
            <a:lvl4pPr marL="1512875" indent="0">
              <a:buNone/>
              <a:defRPr sz="1103"/>
            </a:lvl4pPr>
            <a:lvl5pPr marL="2017166" indent="0">
              <a:buNone/>
              <a:defRPr sz="1103"/>
            </a:lvl5pPr>
            <a:lvl6pPr marL="2521458" indent="0">
              <a:buNone/>
              <a:defRPr sz="1103"/>
            </a:lvl6pPr>
            <a:lvl7pPr marL="3025750" indent="0">
              <a:buNone/>
              <a:defRPr sz="1103"/>
            </a:lvl7pPr>
            <a:lvl8pPr marL="3530041" indent="0">
              <a:buNone/>
              <a:defRPr sz="1103"/>
            </a:lvl8pPr>
            <a:lvl9pPr marL="4034333" indent="0">
              <a:buNone/>
              <a:defRPr sz="110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081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6126" y="402738"/>
            <a:ext cx="9485948" cy="1462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6126" y="2013682"/>
            <a:ext cx="9485948" cy="47995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6126" y="7011115"/>
            <a:ext cx="2474595" cy="4027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43154" y="7011115"/>
            <a:ext cx="3711893" cy="4027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67479" y="7011115"/>
            <a:ext cx="2474595" cy="4027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6546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008583" rtl="0" eaLnBrk="1" latinLnBrk="0" hangingPunct="1">
        <a:lnSpc>
          <a:spcPct val="90000"/>
        </a:lnSpc>
        <a:spcBef>
          <a:spcPct val="0"/>
        </a:spcBef>
        <a:buNone/>
        <a:defRPr sz="48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146" indent="-252146" algn="l" defTabSz="1008583" rtl="0" eaLnBrk="1" latinLnBrk="0" hangingPunct="1">
        <a:lnSpc>
          <a:spcPct val="90000"/>
        </a:lnSpc>
        <a:spcBef>
          <a:spcPts val="1103"/>
        </a:spcBef>
        <a:buFont typeface="Arial" panose="020B0604020202020204" pitchFamily="34" charset="0"/>
        <a:buChar char="•"/>
        <a:defRPr sz="3088" kern="1200">
          <a:solidFill>
            <a:schemeClr val="tx1"/>
          </a:solidFill>
          <a:latin typeface="+mn-lt"/>
          <a:ea typeface="+mn-ea"/>
          <a:cs typeface="+mn-cs"/>
        </a:defRPr>
      </a:lvl1pPr>
      <a:lvl2pPr marL="756437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2647" kern="1200">
          <a:solidFill>
            <a:schemeClr val="tx1"/>
          </a:solidFill>
          <a:latin typeface="+mn-lt"/>
          <a:ea typeface="+mn-ea"/>
          <a:cs typeface="+mn-cs"/>
        </a:defRPr>
      </a:lvl2pPr>
      <a:lvl3pPr marL="1260729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2206" kern="1200">
          <a:solidFill>
            <a:schemeClr val="tx1"/>
          </a:solidFill>
          <a:latin typeface="+mn-lt"/>
          <a:ea typeface="+mn-ea"/>
          <a:cs typeface="+mn-cs"/>
        </a:defRPr>
      </a:lvl3pPr>
      <a:lvl4pPr marL="1765021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4pPr>
      <a:lvl5pPr marL="2269312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5pPr>
      <a:lvl6pPr marL="2773604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6pPr>
      <a:lvl7pPr marL="3277895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7pPr>
      <a:lvl8pPr marL="3782187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8pPr>
      <a:lvl9pPr marL="4286479" indent="-252146" algn="l" defTabSz="1008583" rtl="0" eaLnBrk="1" latinLnBrk="0" hangingPunct="1">
        <a:lnSpc>
          <a:spcPct val="90000"/>
        </a:lnSpc>
        <a:spcBef>
          <a:spcPts val="552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1pPr>
      <a:lvl2pPr marL="504292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1008583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3pPr>
      <a:lvl4pPr marL="1512875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4pPr>
      <a:lvl5pPr marL="2017166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5pPr>
      <a:lvl6pPr marL="2521458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6pPr>
      <a:lvl7pPr marL="3025750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7pPr>
      <a:lvl8pPr marL="3530041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8pPr>
      <a:lvl9pPr marL="4034333" algn="l" defTabSz="1008583" rtl="0" eaLnBrk="1" latinLnBrk="0" hangingPunct="1">
        <a:defRPr sz="19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1462" y="1056094"/>
            <a:ext cx="10492900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ine Resource 6. 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s from baseline in EuroQol-5 dimension (EQ-5D) (Total Study Cohort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01462" y="6870972"/>
            <a:ext cx="10544088" cy="58477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mber of evaluable patients (denominator for percentages), </a:t>
            </a: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mber of patients with characteristic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each visit for each dimension, significantly more patients improved than worsened (</a:t>
            </a: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1; Wilcoxon signed rank test)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orsening is defined as a numeric change &gt;0 (i.e., more pain or discomfort; higher degree of depression or anxiety).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mprovement is defined as a numeric change &lt;0 (i.e., fewer problems, pain or discomfort; lower degree of depression or anxiety)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3077503"/>
              </p:ext>
            </p:extLst>
          </p:nvPr>
        </p:nvGraphicFramePr>
        <p:xfrm>
          <a:off x="252650" y="1345650"/>
          <a:ext cx="10492900" cy="5498012"/>
        </p:xfrm>
        <a:graphic>
          <a:graphicData uri="http://schemas.openxmlformats.org/drawingml/2006/table">
            <a:tbl>
              <a:tblPr firstRow="1" firstCol="1" bandRow="1"/>
              <a:tblGrid>
                <a:gridCol w="172193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3950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418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4189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4189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7776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7776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6348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843673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960490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882613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158404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Q-5D dimension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uring teriparatide treatment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fter teriparatide discontinued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9950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months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 months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months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 months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 months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obility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9950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en-US" sz="900" baseline="30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3 (18.1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4 (22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9 (25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9 (29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8 (29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3 (37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2 (19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2 (39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89 (75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48 (71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1 (70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9 (6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1 (65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1 (57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9 (73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9 (57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 (6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3 (6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 (4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 (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 (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 (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 (7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 (3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lf care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9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29950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3 (1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9 (21.7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6 (22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3 (23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9 (25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4 (32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 (21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5 (31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4 (76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66 (72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24 (72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8 (71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14 (68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6 (64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0 (71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7 (63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 (5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 (5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 (5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 (5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 (6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3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 (7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 (5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sual activities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9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29950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en-US" sz="900" baseline="30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7 (27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1 (30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1 (35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8 (38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9 (36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2 (45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6 (34.7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7 (47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5 (64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5 (62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72 (58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9 (54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5 (55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3 (50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5 (59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9 (45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 (8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9 (7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2 (6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8 (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 (8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 (4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 (6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 (6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29950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in and discomfort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8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0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29950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5 (25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9 (34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3 (37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7 (41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95 (43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9 (5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 (32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3 (51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5 (67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24 (60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0 (56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6 (53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0 (51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7 (42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7 (62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3 (44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0 (6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 (5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 (5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 (5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 (5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 (4.6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5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58404">
                <a:tc gridSpan="11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xiety and depression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58404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2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1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4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96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5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4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229950">
                <a:tc rowSpan="3"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s (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[%]) showing: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8 (22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5 (2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7 (27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3 (30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4 (32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3 (35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 (27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8 (38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2299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8 (67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5 (63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0 (61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27 (58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16 (57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4 (52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3 (61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5 (49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6781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 (10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2 (10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4 (10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 (10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6 (9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1 (11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 (11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1 (11.8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5587" marR="55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31073F5-B098-4BEA-8ECA-E73994FB4A86}"/>
              </a:ext>
            </a:extLst>
          </p:cNvPr>
          <p:cNvSpPr txBox="1"/>
          <p:nvPr/>
        </p:nvSpPr>
        <p:spPr>
          <a:xfrm>
            <a:off x="201462" y="180794"/>
            <a:ext cx="10459510" cy="78483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36352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819</Words>
  <Application>Microsoft Office PowerPoint</Application>
  <PresentationFormat>Custom</PresentationFormat>
  <Paragraphs>2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12</cp:revision>
  <cp:lastPrinted>2018-01-17T10:52:27Z</cp:lastPrinted>
  <dcterms:created xsi:type="dcterms:W3CDTF">2017-07-05T13:17:28Z</dcterms:created>
  <dcterms:modified xsi:type="dcterms:W3CDTF">2018-01-18T14:00:02Z</dcterms:modified>
</cp:coreProperties>
</file>